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0540"/>
    <p:restoredTop sz="96327"/>
  </p:normalViewPr>
  <p:slideViewPr>
    <p:cSldViewPr snapToGrid="0">
      <p:cViewPr varScale="1">
        <p:scale>
          <a:sx n="86" d="100"/>
          <a:sy n="86" d="100"/>
        </p:scale>
        <p:origin x="103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CBFAC4D-323F-7419-E900-16C619D3860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F97D3182-7F90-B5AD-DE61-B7764F43B06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1EAD0C4-5098-99AE-ECA4-5FF7EB967F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E68493-4532-E14C-8548-F19E471C667D}" type="datetimeFigureOut">
              <a:rPr kumimoji="1" lang="ja-JP" altLang="en-US" smtClean="0"/>
              <a:t>2023/6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421A082-46C8-F348-D6D6-44FE1954A7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4AB672D-30E8-5CCF-9C68-C59D806E34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BCAD8-A3F0-B143-AC66-ABB4504EC3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89978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9CB0CF1-24D3-4D44-A034-F9CF06CC8C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FB0FEC3-E798-7DC3-23DC-CB4BC2D1A0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B1EAC98-2D54-8B47-8B5D-46179E88A1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E68493-4532-E14C-8548-F19E471C667D}" type="datetimeFigureOut">
              <a:rPr kumimoji="1" lang="ja-JP" altLang="en-US" smtClean="0"/>
              <a:t>2023/6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B4CF2AE-EA6D-BA92-70BF-B4A4F6C3B1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04F0ECD-44BC-6961-3813-8D911EC2FD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BCAD8-A3F0-B143-AC66-ABB4504EC3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75320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BDFEBA7C-5C40-8857-3C68-26866CD6116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9F2E295-B32B-4C08-8445-490B9FFBB3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52B04BC-B51C-3076-FDE9-2E9DC53401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E68493-4532-E14C-8548-F19E471C667D}" type="datetimeFigureOut">
              <a:rPr kumimoji="1" lang="ja-JP" altLang="en-US" smtClean="0"/>
              <a:t>2023/6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43C6675-3996-4C24-902D-682DC9C2D9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0DF854B-8A32-FE80-D498-987AC4F3F2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BCAD8-A3F0-B143-AC66-ABB4504EC3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06849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EAD869A-BC53-CF57-2B49-F10AAE66E6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487E947-3DB5-7AFC-4CAF-BDE02D528BE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26BDB41-063E-A6EA-1677-279341574A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E68493-4532-E14C-8548-F19E471C667D}" type="datetimeFigureOut">
              <a:rPr kumimoji="1" lang="ja-JP" altLang="en-US" smtClean="0"/>
              <a:t>2023/6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05CC8A7-B2D7-99F3-717C-F262A4B58A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C5116D8-2CAC-6639-1A0C-AFE70E4ACB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BCAD8-A3F0-B143-AC66-ABB4504EC3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08021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2D088A0-AC03-0E7F-A868-B75DEB14BC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13AD5EF-6BE0-7B14-1AE9-1BB76D5E71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6CBC1DA-B533-DC7C-B27C-DEB5FF8C92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E68493-4532-E14C-8548-F19E471C667D}" type="datetimeFigureOut">
              <a:rPr kumimoji="1" lang="ja-JP" altLang="en-US" smtClean="0"/>
              <a:t>2023/6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00DDE7D-1D77-1EF9-5651-60BB6EB66F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57C3C70-73EE-ACF2-0733-77159CCD19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BCAD8-A3F0-B143-AC66-ABB4504EC3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19871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E5A456F-A3C2-1FE1-31CB-E94D1A5C8F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C1A23C5-570C-9986-8ED8-EB256ED16CC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AA249B1-90FC-C7FB-C0D0-29216E449CA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9CC046F-3857-43DB-BB0B-44080B03EC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E68493-4532-E14C-8548-F19E471C667D}" type="datetimeFigureOut">
              <a:rPr kumimoji="1" lang="ja-JP" altLang="en-US" smtClean="0"/>
              <a:t>2023/6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C229BEF-4CD3-995F-B175-4AD5FCF189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797AB57-817A-C2DF-1A89-4829454A7A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BCAD8-A3F0-B143-AC66-ABB4504EC3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97229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52AC0CF-3A74-573A-E8FE-580519C29E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EB3E4B3-318D-2360-AFAE-424BFC2B9C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5361937-C8DF-B265-4F70-BFD4C4CB2A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DB0E26F8-7F1F-45FC-0F54-19EFDBAB867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1D144504-99C5-76FB-BB26-B8A91BD5544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72E65F2B-0A78-4AB0-0D0E-577AFC2969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E68493-4532-E14C-8548-F19E471C667D}" type="datetimeFigureOut">
              <a:rPr kumimoji="1" lang="ja-JP" altLang="en-US" smtClean="0"/>
              <a:t>2023/6/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1F679A64-DE2A-FCF7-C34C-0C9EFDC2CE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5336573-96EE-C5AC-D2E3-80CF213A9C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BCAD8-A3F0-B143-AC66-ABB4504EC3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50684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45AA97A-A695-2212-096D-F78B40CFF5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CA43BF5-FB73-14B1-FBA7-D0C81D01F8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E68493-4532-E14C-8548-F19E471C667D}" type="datetimeFigureOut">
              <a:rPr kumimoji="1" lang="ja-JP" altLang="en-US" smtClean="0"/>
              <a:t>2023/6/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787897A-0C94-2435-D78E-0D417190F5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F9C0BDB8-DEF7-A315-DD15-5E565EBAA9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BCAD8-A3F0-B143-AC66-ABB4504EC3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49488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2EEB666B-BEE7-79DD-885B-5BD154CBB1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E68493-4532-E14C-8548-F19E471C667D}" type="datetimeFigureOut">
              <a:rPr kumimoji="1" lang="ja-JP" altLang="en-US" smtClean="0"/>
              <a:t>2023/6/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6D3CA6BE-F9D4-E68F-44FC-8896E7496B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EEEEC61A-1709-BB9A-601A-A2892B8E0C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BCAD8-A3F0-B143-AC66-ABB4504EC3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77634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FDEFFA3-64C9-49DD-05C9-4C28CAFDCA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3B73438-2582-7C02-EF35-4355759F961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11C3E3F-0522-6E03-8B36-F80FF66250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0E31BF5-E96C-A98D-1120-17823BA6C0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E68493-4532-E14C-8548-F19E471C667D}" type="datetimeFigureOut">
              <a:rPr kumimoji="1" lang="ja-JP" altLang="en-US" smtClean="0"/>
              <a:t>2023/6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D075087-5715-75D5-1310-1C10FE94D6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4612653-FED4-CCB4-7403-34F6668C21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BCAD8-A3F0-B143-AC66-ABB4504EC3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15853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8FD8DD2-FB31-CA88-0A4D-E39094E301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A3D060DD-5D1E-28EC-19C1-4930C3CF080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557838B-4F9F-265F-61A6-C2140821B6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E57E2DE-A4FA-15E5-0DB7-BEC4025ED9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E68493-4532-E14C-8548-F19E471C667D}" type="datetimeFigureOut">
              <a:rPr kumimoji="1" lang="ja-JP" altLang="en-US" smtClean="0"/>
              <a:t>2023/6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02B49EE-4491-3DA2-53AE-0995586689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394650A-FFE7-D917-2581-001B996151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BCAD8-A3F0-B143-AC66-ABB4504EC3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43167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08A2FF39-C89A-EA67-E7A5-AB02A00121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048C079-F485-541E-49A2-818C73D3B2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F17CA33-26A2-5747-B4B8-1FD8E7F266A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E68493-4532-E14C-8548-F19E471C667D}" type="datetimeFigureOut">
              <a:rPr kumimoji="1" lang="ja-JP" altLang="en-US" smtClean="0"/>
              <a:t>2023/6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208FC1E-D4FA-53B2-2695-2BACE654E4B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50CADFC-3B1F-9945-355D-C7AEB88C4A0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CBCAD8-A3F0-B143-AC66-ABB4504EC33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74468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492A0477-F5F4-2DD9-1773-42F5A71AFFF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124" t="28123" r="1373" b="27107"/>
          <a:stretch/>
        </p:blipFill>
        <p:spPr>
          <a:xfrm>
            <a:off x="926756" y="1661984"/>
            <a:ext cx="10779691" cy="3534032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D490BF4-BF2B-0CF8-07BA-36F04E6710BC}"/>
              </a:ext>
            </a:extLst>
          </p:cNvPr>
          <p:cNvSpPr txBox="1"/>
          <p:nvPr/>
        </p:nvSpPr>
        <p:spPr>
          <a:xfrm>
            <a:off x="556054" y="383059"/>
            <a:ext cx="28696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ry Figure S1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9280698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28FF7359-54CE-36DA-1B73-94ED4B4C85D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5639" t="20023" r="18543" b="14283"/>
          <a:stretch/>
        </p:blipFill>
        <p:spPr>
          <a:xfrm>
            <a:off x="1622855" y="716692"/>
            <a:ext cx="8129053" cy="5733535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F6898AB-0B3C-A73C-BBCF-5300DEFB32A2}"/>
              </a:ext>
            </a:extLst>
          </p:cNvPr>
          <p:cNvSpPr txBox="1"/>
          <p:nvPr/>
        </p:nvSpPr>
        <p:spPr>
          <a:xfrm>
            <a:off x="556054" y="383059"/>
            <a:ext cx="28696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ry </a:t>
            </a:r>
            <a:r>
              <a:rPr lang="en-US" altLang="ja-JP" dirty="0"/>
              <a:t>Figure S2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3095826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13F4D458-78E5-B4A0-A914-5E5D94D8433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509" t="16423" r="4553" b="12483"/>
          <a:stretch/>
        </p:blipFill>
        <p:spPr>
          <a:xfrm>
            <a:off x="895604" y="939114"/>
            <a:ext cx="10400792" cy="5745892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42F2A87-5992-E04D-4CE1-776F24B667B5}"/>
              </a:ext>
            </a:extLst>
          </p:cNvPr>
          <p:cNvSpPr txBox="1"/>
          <p:nvPr/>
        </p:nvSpPr>
        <p:spPr>
          <a:xfrm>
            <a:off x="556054" y="383059"/>
            <a:ext cx="28696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ry </a:t>
            </a:r>
            <a:r>
              <a:rPr lang="en-US" altLang="ja-JP" dirty="0"/>
              <a:t>Figure S3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2012403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1">
            <a:extLst>
              <a:ext uri="{FF2B5EF4-FFF2-40B4-BE49-F238E27FC236}">
                <a16:creationId xmlns:a16="http://schemas.microsoft.com/office/drawing/2014/main" id="{657AF294-CD92-F0A1-F26B-D5E302A6EB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62683" y="329921"/>
            <a:ext cx="6261842" cy="19389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kumimoji="0"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</a:t>
            </a: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 Cell type-specific ProTα release induced by various types of stress.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28600" marR="0" lvl="0" indent="-2286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AutoNum type="alphaUcPeriod"/>
              <a:tabLst/>
            </a:pP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ack of ProTα release from microglia by serum-deprivation stress. U</a:t>
            </a:r>
            <a:r>
              <a:rPr kumimoji="0" lang="ja-JP" altLang="ja-JP" sz="12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per panel</a:t>
            </a: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ProTα</a:t>
            </a: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endParaRPr kumimoji="0" lang="en-US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R="0" lvl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 highly acidic protein, purified from 5 x 10</a:t>
            </a:r>
            <a:r>
              <a:rPr kumimoji="0" lang="ja-JP" altLang="ja-JP" sz="12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ells using a phenol extraction procedure was </a:t>
            </a:r>
            <a:endParaRPr kumimoji="0" lang="en-US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R="0" lvl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isualized with Coomassie brilliant blue. Lower panel: Quantitative r</a:t>
            </a: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sults of ProTα levels </a:t>
            </a:r>
            <a:endParaRPr kumimoji="0" lang="en-US" altLang="ja-JP" sz="12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R="0" lvl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 the cell or CM. Details of protocol was reported previously [27]. </a:t>
            </a: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roTα release from </a:t>
            </a:r>
            <a:endParaRPr kumimoji="0" lang="en-US" altLang="ja-JP" sz="12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R="0" lvl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6 glioma cells by lower concentrations of serum, oxygen glucose deprivation (OGD) or </a:t>
            </a:r>
            <a:endParaRPr kumimoji="0" lang="en-US" altLang="ja-JP" sz="12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R="0" lvl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at shock stress. </a:t>
            </a: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.</a:t>
            </a: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Lack of ProTα release from HeLa cells by serum deprivation or heat </a:t>
            </a:r>
            <a:endParaRPr kumimoji="0" lang="en-US" altLang="ja-JP" sz="12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R="0" lvl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hock stress. The decrease of ProTα cell contents by serum deprivation was time dependent. </a:t>
            </a:r>
            <a:endParaRPr kumimoji="0" lang="en-US" altLang="ja-JP" sz="12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R="0" lvl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ower size of ProTα due to cleavage by caspase-3 was observed at 6 or 12 h serum-deprivation </a:t>
            </a:r>
            <a:endParaRPr kumimoji="0" lang="en-US" altLang="ja-JP" sz="12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R="0" lvl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ulture. There was no ProTα release in the CM. 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angle 1">
            <a:extLst>
              <a:ext uri="{FF2B5EF4-FFF2-40B4-BE49-F238E27FC236}">
                <a16:creationId xmlns:a16="http://schemas.microsoft.com/office/drawing/2014/main" id="{E6A2259C-7B9C-3F2B-6F82-A56C7CBC2E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62683" y="2441691"/>
            <a:ext cx="6265561" cy="10156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kumimoji="0"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</a:t>
            </a: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 type-specific expression of key molecules involved in stress-</a:t>
            </a:r>
            <a:endParaRPr kumimoji="0" lang="en-US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duced ProT</a:t>
            </a: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  <a:sym typeface="Symbol" pitchFamily="2" charset="2"/>
              </a:rPr>
              <a:t></a:t>
            </a: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release.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  <a:sym typeface="Symbol" pitchFamily="2" charset="2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Symbol" pitchFamily="2" charset="2"/>
              </a:rPr>
              <a:t>Immunoblot of key molecules in cortical neurons, astrocytes, and microglia (A) </a:t>
            </a: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Symbol" pitchFamily="2" charset="2"/>
              </a:rPr>
              <a:t>and in Hela </a:t>
            </a:r>
            <a:endParaRPr kumimoji="0" lang="en-US" altLang="ja-JP" sz="12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  <a:sym typeface="Symbol" pitchFamily="2" charset="2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Symbol" pitchFamily="2" charset="2"/>
              </a:rPr>
              <a:t>cells and C6 glioma cells (</a:t>
            </a: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Symbol" pitchFamily="2" charset="2"/>
              </a:rPr>
              <a:t>B</a:t>
            </a: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Symbol" pitchFamily="2" charset="2"/>
              </a:rPr>
              <a:t>). Abbreviations: Syt-1, synaptotagmin-1; Stx-1, syntaxin-1; ANXA2, </a:t>
            </a:r>
            <a:endParaRPr kumimoji="0" lang="en-US" altLang="ja-JP" sz="12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  <a:sym typeface="Symbol" pitchFamily="2" charset="2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Symbol" pitchFamily="2" charset="2"/>
              </a:rPr>
              <a:t>annexin A2. Details of protocol are previously reported </a:t>
            </a: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Symbol" pitchFamily="2" charset="2"/>
              </a:rPr>
              <a:t>[42].</a:t>
            </a:r>
            <a:endParaRPr kumimoji="0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ＭＳ 明朝" panose="02020609040205080304" pitchFamily="49" charset="-128"/>
              <a:cs typeface="Times New Roman" panose="02020603050405020304" pitchFamily="18" charset="0"/>
              <a:sym typeface="Symbol" pitchFamily="2" charset="2"/>
            </a:endParaRPr>
          </a:p>
        </p:txBody>
      </p:sp>
      <p:sp>
        <p:nvSpPr>
          <p:cNvPr id="8" name="Rectangle 2">
            <a:extLst>
              <a:ext uri="{FF2B5EF4-FFF2-40B4-BE49-F238E27FC236}">
                <a16:creationId xmlns:a16="http://schemas.microsoft.com/office/drawing/2014/main" id="{E2D33980-4EB2-E8BA-AEA2-95176705DC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73904" y="3630132"/>
            <a:ext cx="6099747" cy="17543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</a:t>
            </a: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y </a:t>
            </a:r>
            <a:r>
              <a:rPr kumimoji="0" lang="en-US" altLang="ja-JP" sz="1200" b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kumimoji="0"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posed schematic mechanisms underlying the blockade of </a:t>
            </a:r>
            <a:endParaRPr kumimoji="0" lang="en-US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morrhage by ProTα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 the transient middle cerebral artery occlusion (tMCAO)-induced ischemia model, systemic </a:t>
            </a:r>
            <a:endParaRPr kumimoji="0" lang="en-US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Tα protects neurons from ischemic damage and suppresses the production of matrix </a:t>
            </a:r>
            <a:endParaRPr kumimoji="0" lang="en-US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talloproteases (MMPs) in microglia. When tissue plasminogen activator (tPA) was given </a:t>
            </a:r>
            <a:endParaRPr kumimoji="0" lang="en-US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 the late time point (6 h) after the tMCAO, the production of MMPs was observed in vascular </a:t>
            </a:r>
            <a:endParaRPr kumimoji="0" lang="en-US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ndothelial cells as well as microglia, and hemorrhage was induced. The co-administration of </a:t>
            </a:r>
            <a:endParaRPr kumimoji="0" lang="en-US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Tα with the late tPA abolished the production of MMPs both in microglia and vascular cells </a:t>
            </a:r>
            <a:endParaRPr kumimoji="0" lang="en-US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hemorrhage [59]. 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627862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8</TotalTime>
  <Words>1599</Words>
  <Application>Microsoft Office PowerPoint</Application>
  <PresentationFormat>Widescreen</PresentationFormat>
  <Paragraphs>2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1" baseType="lpstr">
      <vt:lpstr>ＭＳ 明朝</vt:lpstr>
      <vt:lpstr>游ゴシック</vt:lpstr>
      <vt:lpstr>游ゴシック Light</vt:lpstr>
      <vt:lpstr>Arial</vt:lpstr>
      <vt:lpstr>Symbol</vt:lpstr>
      <vt:lpstr>Times New Roman</vt:lpstr>
      <vt:lpstr>Office テーマ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植田 弘師</dc:creator>
  <cp:lastModifiedBy>MDPI</cp:lastModifiedBy>
  <cp:revision>6</cp:revision>
  <dcterms:created xsi:type="dcterms:W3CDTF">2023-05-04T10:26:53Z</dcterms:created>
  <dcterms:modified xsi:type="dcterms:W3CDTF">2023-06-06T11:05:04Z</dcterms:modified>
</cp:coreProperties>
</file>